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72" r:id="rId2"/>
    <p:sldId id="273" r:id="rId3"/>
    <p:sldId id="268" r:id="rId4"/>
    <p:sldId id="269" r:id="rId5"/>
    <p:sldId id="270" r:id="rId6"/>
    <p:sldId id="271" r:id="rId7"/>
    <p:sldId id="256" r:id="rId8"/>
    <p:sldId id="257" r:id="rId9"/>
    <p:sldId id="258" r:id="rId10"/>
    <p:sldId id="259" r:id="rId11"/>
    <p:sldId id="260" r:id="rId12"/>
    <p:sldId id="261" r:id="rId13"/>
    <p:sldId id="262" r:id="rId14"/>
    <p:sldId id="263" r:id="rId15"/>
    <p:sldId id="264" r:id="rId16"/>
    <p:sldId id="265" r:id="rId17"/>
    <p:sldId id="266" r:id="rId18"/>
    <p:sldId id="267" r:id="rId1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84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C76E41-58D4-4033-BB95-8A4535A602DD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63CCC8-2EA1-4C7D-85CC-2A12285A86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5657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6E0E4-14E5-412C-9EF9-0637931244D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73932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6E0E4-14E5-412C-9EF9-0637931244D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43892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6E0E4-14E5-412C-9EF9-0637931244D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22985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6E0E4-14E5-412C-9EF9-0637931244DC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724147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6E0E4-14E5-412C-9EF9-0637931244DC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191734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6E0E4-14E5-412C-9EF9-0637931244DC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7625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94E8C7-758A-37BD-64D6-73B1018547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3BA4737-EFC8-3386-24E8-E27DCE4613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1EFA7E-E9E0-68F1-2017-7A48EA9AF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3B2369-19D2-15E2-E297-8B6DE7F170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62436F-3806-12F1-0CF7-8FBF920FF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116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CB5438-784B-D433-1700-8D5D6017E2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58CBF1C-144F-BF1F-28F2-72FADC7DEB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732873-B582-DA23-E741-ACCB38C05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319A593-D6DD-8D1C-C4A0-36B7FC741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3760F0-612B-3B59-04E1-48453B31E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753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65C07E7-A970-B3BE-540A-DE118FF103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53EAB99-BC98-33CB-BB85-52709B9FAD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0868DB-56C0-498D-757D-7B51DDBCC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765916-D199-36BC-8C44-135758CBC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A53C0F-F040-B91F-97CF-12FEFEF15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9053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3AE10A-8F57-5026-0C25-A42C5AFDCA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DC56281-D319-B6E8-2B78-59CEE832AF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5CB8D4-5082-3E27-0ACD-73E4628521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DD0CB9-2C02-EAD8-5D17-ABD02EC3F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F608E0-14AE-5869-AAAB-AECDF7313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9284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F24D43-131E-F772-91EB-EB36A96CE8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488227-AEA5-A084-3B16-FB6FD9CB75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977B07-889A-70BA-A696-CC8673287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55BDBE-05FC-D6B5-8C07-864C46F92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3AF8A7-3E45-5BC6-7C3A-7BB1DB6F7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4138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517DFF-B035-E425-EFDC-E7B2CB8DD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F25A56-62CE-DE0D-918B-7F69917179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D107769-6700-D279-DF07-4A4A38F034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A5A96A6-364A-B219-4439-E3B61D592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8D2908-9DD2-93DD-CD12-0956309FF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436F84-885C-550A-2B2B-77BDA3DED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2103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AB889A-5C20-27CA-5031-C7DE72FEA3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B8FF19-2985-EC62-FAF2-86AB414EE9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78AB948-47C8-7486-D4BC-D7FAB076D6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E7F3359-CB46-0E15-B0CF-9F389CE0EE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067E7CC-8C6E-BA6A-25AB-D9F3BEBE31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7ED0037-C1F2-B875-AD11-9E0F3006E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1B07644-2497-A081-DF8E-625B270BE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F2AFBBB-BC96-4133-428D-3EF937DC2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5848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98A896-C23B-2799-89B0-49E0F50277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E9F0E14-7313-F1ED-FF91-1D97C85EE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ED7A0E9-49FA-2BFA-2528-C2DF63952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3F1FBB1-D4A4-4B10-E219-4FC33FC9E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2183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6702A23-0D4C-AE33-14A0-9D4EEBE6D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24FCBB5-0D4C-80F3-6979-806DBAE65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DC2401B-CF4C-1992-AB8F-02B58ADE9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5644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FF873C-D774-96C5-A517-867ED8F26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D7D63E-676D-45A3-D444-57FA1BE11B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A9C2A3A-1526-6736-6725-63B6853A10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293EF4D-4D6A-E5F1-1980-4EE04EE1F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D80F9A-3618-0C5E-FFAC-DFF7E1BCE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B9DDA7-0880-13ED-40E9-B4D406438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3953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EDFE23-8510-1789-C750-9F7CAEBDA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913F742-D9FC-7A73-557B-1BD4BDACD9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33FEF6B-AC13-122D-36D1-29BBC549DE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CF5439A-641C-250F-3718-080AB67E6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DC2775-4E66-35AB-1F0E-28B6075B0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5E1048-7B53-BA7C-E610-DDC9A855F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6862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DC18FCF-2250-B852-A08E-B9D7ECDF5B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A89C56B-8EDC-9279-7DB6-A64EEB103F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80CCEA-E5F0-32DF-1A3A-8BAEF7113C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8822F-9C47-4B52-A9A1-718FEAD18DC6}" type="datetimeFigureOut">
              <a:rPr lang="zh-CN" altLang="en-US" smtClean="0"/>
              <a:t>2022/9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876FDF-AEE3-25B6-4C46-A76C592636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E710EA-5EBF-B09A-31C1-5753C177CD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34281-AAA1-4AB5-B763-C3B8B25489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8750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BA43344-146C-C869-8D24-D4BA2B27C3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742899"/>
            <a:ext cx="12192000" cy="537220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6D947FB-EC2F-0177-032D-7D3DA89B13F6}"/>
              </a:ext>
            </a:extLst>
          </p:cNvPr>
          <p:cNvSpPr txBox="1"/>
          <p:nvPr/>
        </p:nvSpPr>
        <p:spPr>
          <a:xfrm>
            <a:off x="2126804" y="6488668"/>
            <a:ext cx="8148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Output of segmental artery of the algorithm in case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30578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FAAE70A-DC27-51EF-09EE-B495056473C8}"/>
              </a:ext>
            </a:extLst>
          </p:cNvPr>
          <p:cNvSpPr txBox="1"/>
          <p:nvPr/>
        </p:nvSpPr>
        <p:spPr>
          <a:xfrm>
            <a:off x="3701755" y="6488668"/>
            <a:ext cx="4865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0. case #15 LA3 error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2B6C9043-8FED-0AD0-404B-32395A1A05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9918" y="1520727"/>
            <a:ext cx="4172164" cy="38165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81049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42223B9-E9A6-9507-87CF-F4D8D3DC6D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8868" y="415770"/>
            <a:ext cx="7074264" cy="602646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3197F08-613F-5675-FD39-9C4049994683}"/>
              </a:ext>
            </a:extLst>
          </p:cNvPr>
          <p:cNvSpPr txBox="1"/>
          <p:nvPr/>
        </p:nvSpPr>
        <p:spPr>
          <a:xfrm>
            <a:off x="3691079" y="6488668"/>
            <a:ext cx="48867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1. case #16 RA2 erro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53606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7F6E7BC-57AB-DA29-3AFD-9364A1DDB536}"/>
              </a:ext>
            </a:extLst>
          </p:cNvPr>
          <p:cNvSpPr txBox="1"/>
          <p:nvPr/>
        </p:nvSpPr>
        <p:spPr>
          <a:xfrm>
            <a:off x="3393979" y="6488668"/>
            <a:ext cx="5480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2. case #19 RA2, RA3 error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3B4136E-7B52-55DB-B438-CD37FDC1C7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1821" y="638031"/>
            <a:ext cx="5988358" cy="55819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13112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C9F128F-99F7-9227-5306-9CD92911A7A8}"/>
              </a:ext>
            </a:extLst>
          </p:cNvPr>
          <p:cNvSpPr txBox="1"/>
          <p:nvPr/>
        </p:nvSpPr>
        <p:spPr>
          <a:xfrm>
            <a:off x="3682519" y="6488668"/>
            <a:ext cx="4903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3. case #20 RA6 error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662090F-A4D9-E76C-C729-C5447321C9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9554" y="1396895"/>
            <a:ext cx="4692891" cy="40642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175439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2BE9422-94B1-A7E7-A8F0-21D98A6612A7}"/>
              </a:ext>
            </a:extLst>
          </p:cNvPr>
          <p:cNvSpPr txBox="1"/>
          <p:nvPr/>
        </p:nvSpPr>
        <p:spPr>
          <a:xfrm>
            <a:off x="3551073" y="6488668"/>
            <a:ext cx="5166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4. case #22 RA4+5 error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2513360B-617B-786B-7BC8-FC98880881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8676" y="1720762"/>
            <a:ext cx="3854648" cy="34164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0099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9CE1093-E82D-7151-60B9-5BED95C1FBE8}"/>
              </a:ext>
            </a:extLst>
          </p:cNvPr>
          <p:cNvSpPr txBox="1"/>
          <p:nvPr/>
        </p:nvSpPr>
        <p:spPr>
          <a:xfrm>
            <a:off x="3515807" y="6488668"/>
            <a:ext cx="5237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5. case #24 RA7-10 error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FD9A650-5E05-D3D3-A7CF-CCF7C76E8F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6353" y="369332"/>
            <a:ext cx="5419294" cy="6119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458066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8B50884E-5BB4-917E-EAC4-FCB53F95C563}"/>
              </a:ext>
            </a:extLst>
          </p:cNvPr>
          <p:cNvSpPr txBox="1"/>
          <p:nvPr/>
        </p:nvSpPr>
        <p:spPr>
          <a:xfrm>
            <a:off x="3301004" y="6488668"/>
            <a:ext cx="5666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6. case #25 LA1+2, LA3 error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C81E1DB-3997-B575-219D-85BCEF232E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3169" y="453872"/>
            <a:ext cx="5105662" cy="59502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667357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5FCA39AB-A039-6455-C876-D7725897879F}"/>
              </a:ext>
            </a:extLst>
          </p:cNvPr>
          <p:cNvSpPr txBox="1"/>
          <p:nvPr/>
        </p:nvSpPr>
        <p:spPr>
          <a:xfrm>
            <a:off x="3570309" y="6488668"/>
            <a:ext cx="5128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7. case #27 LA1+2 error</a:t>
            </a:r>
            <a:endParaRPr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B2AB62F-7ACE-23DD-F152-215E85DCE9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1452" y="958723"/>
            <a:ext cx="4769095" cy="49405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46775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114B31A-6874-983A-4300-FD618D25E4AC}"/>
              </a:ext>
            </a:extLst>
          </p:cNvPr>
          <p:cNvSpPr txBox="1"/>
          <p:nvPr/>
        </p:nvSpPr>
        <p:spPr>
          <a:xfrm>
            <a:off x="3310526" y="6488668"/>
            <a:ext cx="5647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18. case #31 A7, A9, A10 error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3983AF6-7330-AABB-9536-35047F9914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7591" y="349089"/>
            <a:ext cx="5636818" cy="61598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7940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44BA0FF-8B2E-FD9B-DE22-91CB7B52C8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48682"/>
            <a:ext cx="12192000" cy="516063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10FD093E-03B3-5564-924C-528E775E937D}"/>
              </a:ext>
            </a:extLst>
          </p:cNvPr>
          <p:cNvSpPr txBox="1"/>
          <p:nvPr/>
        </p:nvSpPr>
        <p:spPr>
          <a:xfrm>
            <a:off x="2318364" y="6488668"/>
            <a:ext cx="7555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Output of lobular vein of the algorithm in case 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7100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7BF02AB-BAE8-1057-9B6D-F40E608232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76250"/>
            <a:ext cx="12192000" cy="590550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22B6C5C-A73E-B5C1-6D56-80AED4FD525D}"/>
              </a:ext>
            </a:extLst>
          </p:cNvPr>
          <p:cNvSpPr txBox="1"/>
          <p:nvPr/>
        </p:nvSpPr>
        <p:spPr>
          <a:xfrm>
            <a:off x="2021808" y="6488668"/>
            <a:ext cx="8148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Output of segmental artery of the algorithm in cas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37774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4330157F-5AD7-D78C-24B3-AEB9228A57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49435"/>
            <a:ext cx="12192000" cy="595912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629D943-B6CC-1989-3A4E-8F5531B730D9}"/>
              </a:ext>
            </a:extLst>
          </p:cNvPr>
          <p:cNvSpPr txBox="1"/>
          <p:nvPr/>
        </p:nvSpPr>
        <p:spPr>
          <a:xfrm>
            <a:off x="2291112" y="6488668"/>
            <a:ext cx="760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Output of lobular vein of the algorithm in cas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39639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5BDD3D2-505E-1B29-C8D6-467B7FA9E4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72242"/>
            <a:ext cx="12192000" cy="571351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BCF5C5DE-1804-6CCA-B073-F81273CBA55E}"/>
              </a:ext>
            </a:extLst>
          </p:cNvPr>
          <p:cNvSpPr txBox="1"/>
          <p:nvPr/>
        </p:nvSpPr>
        <p:spPr>
          <a:xfrm>
            <a:off x="2021808" y="6488668"/>
            <a:ext cx="8148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Output of segmental artery of the algorithm in case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09376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5307F252-D06E-CE7B-6C9E-B4054908A1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13418"/>
            <a:ext cx="12192000" cy="563116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0995F66-B6EE-CD5E-9B49-842550629C12}"/>
              </a:ext>
            </a:extLst>
          </p:cNvPr>
          <p:cNvSpPr txBox="1"/>
          <p:nvPr/>
        </p:nvSpPr>
        <p:spPr>
          <a:xfrm>
            <a:off x="2291112" y="6488668"/>
            <a:ext cx="760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Output of lobular vein of the algorithm in case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2398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9E66BBE-63F1-C14C-0A96-4B89F80F94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77990" y="780914"/>
            <a:ext cx="6236020" cy="529617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731E3B1A-54C3-5D0D-43B8-F5306795DBC0}"/>
              </a:ext>
            </a:extLst>
          </p:cNvPr>
          <p:cNvSpPr txBox="1"/>
          <p:nvPr/>
        </p:nvSpPr>
        <p:spPr>
          <a:xfrm>
            <a:off x="3829995" y="6488668"/>
            <a:ext cx="4608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7. case #7 LA3 erro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935370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247C9D8A-ABDE-A581-E6C6-BCBDEAE712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7914" y="1123831"/>
            <a:ext cx="5296172" cy="461033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5301CA5F-6B5F-C871-9A3F-E00CE6218E1E}"/>
              </a:ext>
            </a:extLst>
          </p:cNvPr>
          <p:cNvSpPr txBox="1"/>
          <p:nvPr/>
        </p:nvSpPr>
        <p:spPr>
          <a:xfrm>
            <a:off x="3746639" y="6488668"/>
            <a:ext cx="4775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 case #10 RA3 erro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48671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2DBC0D81-6994-0177-A77E-ED5B060E63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9803" y="748145"/>
            <a:ext cx="4132394" cy="536171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C1096F2-19E9-E089-C583-188718AF8861}"/>
              </a:ext>
            </a:extLst>
          </p:cNvPr>
          <p:cNvSpPr txBox="1"/>
          <p:nvPr/>
        </p:nvSpPr>
        <p:spPr>
          <a:xfrm>
            <a:off x="3095820" y="6488668"/>
            <a:ext cx="6077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Supplementary Figure 9. case #12 LA1+2, LA4, LA5 erro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14096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10</Words>
  <Application>Microsoft Office PowerPoint</Application>
  <PresentationFormat>宽屏</PresentationFormat>
  <Paragraphs>24</Paragraphs>
  <Slides>18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uyuan Chen</dc:creator>
  <cp:lastModifiedBy>Xiuyuan Chen</cp:lastModifiedBy>
  <cp:revision>10</cp:revision>
  <dcterms:created xsi:type="dcterms:W3CDTF">2022-09-14T06:58:10Z</dcterms:created>
  <dcterms:modified xsi:type="dcterms:W3CDTF">2022-09-14T07:46:43Z</dcterms:modified>
</cp:coreProperties>
</file>